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81" r:id="rId2"/>
  </p:sldIdLst>
  <p:sldSz cx="7772400" cy="10058400"/>
  <p:notesSz cx="6802438" cy="99345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7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169" autoAdjust="0"/>
    <p:restoredTop sz="96144" autoAdjust="0"/>
  </p:normalViewPr>
  <p:slideViewPr>
    <p:cSldViewPr snapToGrid="0">
      <p:cViewPr varScale="1">
        <p:scale>
          <a:sx n="65" d="100"/>
          <a:sy n="65" d="100"/>
        </p:scale>
        <p:origin x="9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988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2863" y="0"/>
            <a:ext cx="2947987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C72701-E2FA-483A-B720-0AF19BC2A5E9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06613" y="1241425"/>
            <a:ext cx="2590800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1038" y="4781550"/>
            <a:ext cx="5441950" cy="39116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6100"/>
            <a:ext cx="2947988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2863" y="9436100"/>
            <a:ext cx="2947987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7BEBD1-C84B-4EE5-84D2-C6D3843686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69543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7BEBD1-C84B-4EE5-84D2-C6D384368605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8095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473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9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06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75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14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028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994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007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712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192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4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6658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1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1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273477" y="1396868"/>
            <a:ext cx="420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9F219E5F-E1CB-49C7-B0E3-ECC865CFAE69}"/>
              </a:ext>
            </a:extLst>
          </p:cNvPr>
          <p:cNvSpPr txBox="1"/>
          <p:nvPr/>
        </p:nvSpPr>
        <p:spPr>
          <a:xfrm>
            <a:off x="41652" y="12977"/>
            <a:ext cx="43681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2BACB09-70E7-464D-BBC7-A40A5DB7BA0D}"/>
              </a:ext>
            </a:extLst>
          </p:cNvPr>
          <p:cNvSpPr txBox="1"/>
          <p:nvPr/>
        </p:nvSpPr>
        <p:spPr>
          <a:xfrm>
            <a:off x="-40036" y="439174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2061358" y="1665956"/>
            <a:ext cx="874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CD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2058776" y="2104530"/>
            <a:ext cx="10805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323843" y="4148186"/>
            <a:ext cx="4255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88">
            <a:extLst>
              <a:ext uri="{FF2B5EF4-FFF2-40B4-BE49-F238E27FC236}">
                <a16:creationId xmlns:a16="http://schemas.microsoft.com/office/drawing/2014/main" id="{5ABF8791-B2A0-4354-B8EE-CA5185C37714}"/>
              </a:ext>
            </a:extLst>
          </p:cNvPr>
          <p:cNvSpPr txBox="1"/>
          <p:nvPr/>
        </p:nvSpPr>
        <p:spPr>
          <a:xfrm>
            <a:off x="2383785" y="6301833"/>
            <a:ext cx="9546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β-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88">
            <a:extLst>
              <a:ext uri="{FF2B5EF4-FFF2-40B4-BE49-F238E27FC236}">
                <a16:creationId xmlns:a16="http://schemas.microsoft.com/office/drawing/2014/main" id="{E535DB71-732C-4EF1-ADB9-A823893C7AA3}"/>
              </a:ext>
            </a:extLst>
          </p:cNvPr>
          <p:cNvSpPr txBox="1"/>
          <p:nvPr/>
        </p:nvSpPr>
        <p:spPr>
          <a:xfrm>
            <a:off x="2383785" y="5340708"/>
            <a:ext cx="9546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NF-ĸB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536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88">
            <a:extLst>
              <a:ext uri="{FF2B5EF4-FFF2-40B4-BE49-F238E27FC236}">
                <a16:creationId xmlns:a16="http://schemas.microsoft.com/office/drawing/2014/main" id="{02DA3E7C-5C85-480F-9C1E-9C56133CE43C}"/>
              </a:ext>
            </a:extLst>
          </p:cNvPr>
          <p:cNvSpPr txBox="1"/>
          <p:nvPr/>
        </p:nvSpPr>
        <p:spPr>
          <a:xfrm>
            <a:off x="2383785" y="5835172"/>
            <a:ext cx="9546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NF-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ĸ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88">
            <a:extLst>
              <a:ext uri="{FF2B5EF4-FFF2-40B4-BE49-F238E27FC236}">
                <a16:creationId xmlns:a16="http://schemas.microsoft.com/office/drawing/2014/main" id="{F9D0CD2A-4968-4EDA-96D6-84F094984028}"/>
              </a:ext>
            </a:extLst>
          </p:cNvPr>
          <p:cNvSpPr txBox="1"/>
          <p:nvPr/>
        </p:nvSpPr>
        <p:spPr>
          <a:xfrm>
            <a:off x="2383785" y="4413017"/>
            <a:ext cx="8088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32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88">
            <a:extLst>
              <a:ext uri="{FF2B5EF4-FFF2-40B4-BE49-F238E27FC236}">
                <a16:creationId xmlns:a16="http://schemas.microsoft.com/office/drawing/2014/main" id="{A8B9035E-76E7-407E-B1D2-B33554620D0C}"/>
              </a:ext>
            </a:extLst>
          </p:cNvPr>
          <p:cNvSpPr txBox="1"/>
          <p:nvPr/>
        </p:nvSpPr>
        <p:spPr>
          <a:xfrm>
            <a:off x="2383785" y="4922338"/>
            <a:ext cx="808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73451" y="5403121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57" t="37609" r="40150" b="50849"/>
          <a:stretch/>
        </p:blipFill>
        <p:spPr>
          <a:xfrm>
            <a:off x="607576" y="1610720"/>
            <a:ext cx="1403094" cy="36582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15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24872" y="151963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72913" y="164615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27832" y="175036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72913" y="187690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39" t="31275" r="42182" b="57132"/>
          <a:stretch/>
        </p:blipFill>
        <p:spPr>
          <a:xfrm>
            <a:off x="3192643" y="1605434"/>
            <a:ext cx="1402289" cy="36746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3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908982" y="1581650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직선 연결선 140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156098" y="170600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908982" y="182012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직선 연결선 14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156098" y="1949633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2851729" y="1396868"/>
            <a:ext cx="4280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4680689" y="1668892"/>
            <a:ext cx="874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CD4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4680689" y="2104530"/>
            <a:ext cx="10805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03" t="34048" r="39549" b="56299"/>
          <a:stretch/>
        </p:blipFill>
        <p:spPr>
          <a:xfrm>
            <a:off x="679237" y="5315578"/>
            <a:ext cx="1702300" cy="40248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98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97435" y="5526101"/>
            <a:ext cx="385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직선 연결선 198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639666" y="5651599"/>
            <a:ext cx="300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95765" y="5223565"/>
            <a:ext cx="385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직선 연결선 201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640293" y="5350565"/>
            <a:ext cx="300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7" name="그림 15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86" t="38992" r="43641" b="51299"/>
          <a:stretch/>
        </p:blipFill>
        <p:spPr>
          <a:xfrm>
            <a:off x="677506" y="4371410"/>
            <a:ext cx="1704031" cy="40481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5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91693" y="4296229"/>
            <a:ext cx="351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635781" y="4424386"/>
            <a:ext cx="273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97B25118-8CB2-4695-82F4-93EAA418417D}"/>
              </a:ext>
            </a:extLst>
          </p:cNvPr>
          <p:cNvSpPr txBox="1"/>
          <p:nvPr/>
        </p:nvSpPr>
        <p:spPr>
          <a:xfrm>
            <a:off x="-40847" y="3269601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그룹 46"/>
          <p:cNvGrpSpPr/>
          <p:nvPr/>
        </p:nvGrpSpPr>
        <p:grpSpPr>
          <a:xfrm>
            <a:off x="669292" y="743507"/>
            <a:ext cx="2492857" cy="810218"/>
            <a:chOff x="526832" y="1093125"/>
            <a:chExt cx="2492857" cy="810218"/>
          </a:xfrm>
        </p:grpSpPr>
        <p:sp>
          <p:nvSpPr>
            <p:cNvPr id="23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 rot="16200000">
              <a:off x="332644" y="1380781"/>
              <a:ext cx="739230" cy="3058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13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644312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0</a:t>
              </a:r>
            </a:p>
          </p:txBody>
        </p:sp>
        <p:sp>
          <p:nvSpPr>
            <p:cNvPr id="13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463276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8</a:t>
              </a:r>
            </a:p>
          </p:txBody>
        </p:sp>
        <p:sp>
          <p:nvSpPr>
            <p:cNvPr id="13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289550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0-V5</a:t>
              </a:r>
            </a:p>
          </p:txBody>
        </p:sp>
        <p:sp>
          <p:nvSpPr>
            <p:cNvPr id="13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099554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8-V5</a:t>
              </a:r>
            </a:p>
          </p:txBody>
        </p:sp>
        <p:sp>
          <p:nvSpPr>
            <p:cNvPr id="14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894511" y="1628923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5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628923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50096" y="1628923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05897" y="144856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44856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3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46138" y="144856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05897" y="1267727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267727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31933" y="1267727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05897" y="109312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7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09312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7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28662" y="109312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4" name="직선 연결선 3"/>
            <p:cNvCxnSpPr/>
            <p:nvPr/>
          </p:nvCxnSpPr>
          <p:spPr>
            <a:xfrm>
              <a:off x="526832" y="1884634"/>
              <a:ext cx="27757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직선 연결선 176"/>
            <p:cNvCxnSpPr/>
            <p:nvPr/>
          </p:nvCxnSpPr>
          <p:spPr>
            <a:xfrm>
              <a:off x="868405" y="1884355"/>
              <a:ext cx="946909" cy="27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" name="그룹 45"/>
          <p:cNvGrpSpPr/>
          <p:nvPr/>
        </p:nvGrpSpPr>
        <p:grpSpPr>
          <a:xfrm>
            <a:off x="748588" y="3506245"/>
            <a:ext cx="2592881" cy="802237"/>
            <a:chOff x="551117" y="3952310"/>
            <a:chExt cx="2467570" cy="802237"/>
          </a:xfrm>
        </p:grpSpPr>
        <p:sp>
          <p:nvSpPr>
            <p:cNvPr id="20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 rot="16200000">
              <a:off x="330563" y="4256084"/>
              <a:ext cx="739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20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2028470" y="4497492"/>
              <a:ext cx="9902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0</a:t>
              </a:r>
            </a:p>
          </p:txBody>
        </p:sp>
        <p:sp>
          <p:nvSpPr>
            <p:cNvPr id="20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2028470" y="4316456"/>
              <a:ext cx="9902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8</a:t>
              </a:r>
            </a:p>
          </p:txBody>
        </p:sp>
        <p:sp>
          <p:nvSpPr>
            <p:cNvPr id="21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2028470" y="4142730"/>
              <a:ext cx="9902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0-V5</a:t>
              </a:r>
            </a:p>
          </p:txBody>
        </p:sp>
        <p:sp>
          <p:nvSpPr>
            <p:cNvPr id="21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2028470" y="3952734"/>
              <a:ext cx="9902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8-V5</a:t>
              </a:r>
            </a:p>
          </p:txBody>
        </p:sp>
        <p:sp>
          <p:nvSpPr>
            <p:cNvPr id="21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84535" y="4492937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343473" y="4488108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40283" y="4488108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92225" y="4312579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343473" y="4307750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3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37097" y="4307750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92225" y="4131741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343473" y="4126912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25663" y="4126912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92225" y="3957139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343473" y="3952310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23030" y="3952310"/>
              <a:ext cx="2507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30" name="직선 연결선 229"/>
            <p:cNvCxnSpPr/>
            <p:nvPr/>
          </p:nvCxnSpPr>
          <p:spPr>
            <a:xfrm>
              <a:off x="551117" y="4736084"/>
              <a:ext cx="2902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직선 연결선 230"/>
            <p:cNvCxnSpPr/>
            <p:nvPr/>
          </p:nvCxnSpPr>
          <p:spPr>
            <a:xfrm>
              <a:off x="928302" y="4736084"/>
              <a:ext cx="11001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2" name="그룹 231"/>
          <p:cNvGrpSpPr/>
          <p:nvPr/>
        </p:nvGrpSpPr>
        <p:grpSpPr>
          <a:xfrm>
            <a:off x="3250820" y="741601"/>
            <a:ext cx="2492857" cy="810218"/>
            <a:chOff x="526832" y="1093125"/>
            <a:chExt cx="2492857" cy="810218"/>
          </a:xfrm>
        </p:grpSpPr>
        <p:sp>
          <p:nvSpPr>
            <p:cNvPr id="233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 rot="16200000">
              <a:off x="332644" y="1380781"/>
              <a:ext cx="739230" cy="3058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23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644312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0</a:t>
              </a:r>
            </a:p>
          </p:txBody>
        </p:sp>
        <p:sp>
          <p:nvSpPr>
            <p:cNvPr id="23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463276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8</a:t>
              </a:r>
            </a:p>
          </p:txBody>
        </p:sp>
        <p:sp>
          <p:nvSpPr>
            <p:cNvPr id="23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289550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0-V5</a:t>
              </a:r>
            </a:p>
          </p:txBody>
        </p:sp>
        <p:sp>
          <p:nvSpPr>
            <p:cNvPr id="23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789490" y="1099554"/>
              <a:ext cx="123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8-V5</a:t>
              </a:r>
            </a:p>
          </p:txBody>
        </p:sp>
        <p:sp>
          <p:nvSpPr>
            <p:cNvPr id="24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894511" y="1628923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628923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50096" y="1628923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05897" y="144856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44856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46138" y="144856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05897" y="1267727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267727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0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31933" y="1267727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0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05897" y="109312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215809" y="109312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0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528662" y="1093125"/>
              <a:ext cx="311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310" name="직선 연결선 309"/>
            <p:cNvCxnSpPr/>
            <p:nvPr/>
          </p:nvCxnSpPr>
          <p:spPr>
            <a:xfrm>
              <a:off x="526832" y="1884634"/>
              <a:ext cx="27757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직선 연결선 310"/>
            <p:cNvCxnSpPr/>
            <p:nvPr/>
          </p:nvCxnSpPr>
          <p:spPr>
            <a:xfrm>
              <a:off x="868405" y="1884355"/>
              <a:ext cx="946909" cy="27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15" t="37322" r="45037" b="55365"/>
          <a:stretch/>
        </p:blipFill>
        <p:spPr>
          <a:xfrm>
            <a:off x="607575" y="2051180"/>
            <a:ext cx="1403095" cy="36841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2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27832" y="2104571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직선 연결선 121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72526" y="222648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50" t="44839" r="35818" b="46706"/>
          <a:stretch/>
        </p:blipFill>
        <p:spPr>
          <a:xfrm>
            <a:off x="3192643" y="2048558"/>
            <a:ext cx="1402290" cy="36757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43" t="55763" r="38886" b="33887"/>
          <a:stretch/>
        </p:blipFill>
        <p:spPr>
          <a:xfrm>
            <a:off x="677506" y="4843849"/>
            <a:ext cx="1704031" cy="4032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30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91693" y="4771841"/>
            <a:ext cx="351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직선 연결선 132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636925" y="4905356"/>
            <a:ext cx="273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09" t="46173" r="37460" b="43093"/>
          <a:stretch/>
        </p:blipFill>
        <p:spPr>
          <a:xfrm>
            <a:off x="677506" y="5783445"/>
            <a:ext cx="1704031" cy="40174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24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401507" y="5974003"/>
            <a:ext cx="385146" cy="245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638825" y="6098385"/>
            <a:ext cx="300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97435" y="5680131"/>
            <a:ext cx="385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직선 연결선 134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639450" y="5809730"/>
            <a:ext cx="300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73452" y="5853808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47" t="33401" r="44359" b="59399"/>
          <a:stretch/>
        </p:blipFill>
        <p:spPr>
          <a:xfrm>
            <a:off x="677506" y="6251272"/>
            <a:ext cx="1704031" cy="40186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96483" y="6337177"/>
            <a:ext cx="351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직선 연결선 150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635818" y="6466087"/>
            <a:ext cx="273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Box 151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473451" y="4930792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직선 화살표 연결선 119"/>
          <p:cNvCxnSpPr/>
          <p:nvPr/>
        </p:nvCxnSpPr>
        <p:spPr>
          <a:xfrm flipH="1">
            <a:off x="2027314" y="1784302"/>
            <a:ext cx="99210" cy="0"/>
          </a:xfrm>
          <a:prstGeom prst="straightConnector1">
            <a:avLst/>
          </a:prstGeom>
          <a:ln w="127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직선 화살표 연결선 125"/>
          <p:cNvCxnSpPr/>
          <p:nvPr/>
        </p:nvCxnSpPr>
        <p:spPr>
          <a:xfrm flipH="1">
            <a:off x="2027313" y="1862321"/>
            <a:ext cx="9921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직선 화살표 연결선 139"/>
          <p:cNvCxnSpPr/>
          <p:nvPr/>
        </p:nvCxnSpPr>
        <p:spPr>
          <a:xfrm flipH="1">
            <a:off x="4631084" y="1868608"/>
            <a:ext cx="99210" cy="0"/>
          </a:xfrm>
          <a:prstGeom prst="straightConnector1">
            <a:avLst/>
          </a:prstGeom>
          <a:ln w="127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433B8FF-E290-69CE-0863-8CA426CB37B6}"/>
              </a:ext>
            </a:extLst>
          </p:cNvPr>
          <p:cNvSpPr txBox="1"/>
          <p:nvPr/>
        </p:nvSpPr>
        <p:spPr>
          <a:xfrm>
            <a:off x="227816" y="7840227"/>
            <a:ext cx="7423961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Supplementary FIGURE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</a:t>
            </a:r>
            <a:r>
              <a:rPr lang="en-US" altLang="ko-KR" sz="1200" b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4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Knockdown of </a:t>
            </a:r>
            <a:r>
              <a:rPr lang="en-US" altLang="ko-KR" sz="12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CD48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and </a:t>
            </a:r>
            <a:r>
              <a:rPr lang="en-US" altLang="ko-KR" sz="12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CD40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genes and evaluation of</a:t>
            </a:r>
            <a:r>
              <a:rPr lang="en-US" altLang="ko-KR" sz="1200" dirty="0">
                <a:effectLst/>
                <a:latin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NF-</a:t>
            </a:r>
            <a:r>
              <a:rPr lang="en-US" altLang="ko-KR" sz="1200" dirty="0" err="1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ĸB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signaling pathway. (A) The tau biosensor cells were transfected with V5-tagged </a:t>
            </a:r>
            <a:r>
              <a:rPr lang="en-US" altLang="ko-KR" sz="12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CD48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and </a:t>
            </a:r>
            <a:r>
              <a:rPr lang="en-US" altLang="ko-KR" sz="12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CD40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, then incubated for 24 h. After transfection, the cells were treated with </a:t>
            </a:r>
            <a:r>
              <a:rPr lang="en-US" altLang="ko-KR" sz="12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CD48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and </a:t>
            </a:r>
            <a:r>
              <a:rPr lang="en-US" altLang="ko-KR" sz="1200" i="1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CD40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 siRNA (100 </a:t>
            </a:r>
            <a:r>
              <a:rPr lang="en-US" altLang="ko-KR" sz="1200" dirty="0" err="1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nM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), and incubated for 48 h. Protein expression levels to examine the siRNA transfection were identified using western blot by detecting CD48 and CD40 antibodies. (B) </a:t>
            </a:r>
            <a:r>
              <a:rPr lang="en-US" altLang="ko-KR" sz="1200" dirty="0" err="1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pIĸB</a:t>
            </a:r>
            <a:r>
              <a:rPr lang="en-US" altLang="ko-KR" sz="1200" dirty="0">
                <a:effectLst/>
                <a:latin typeface="Arial" panose="020B0604020202020204" pitchFamily="34" charset="0"/>
                <a:ea typeface="맑은 고딕" panose="020B0503020000020004" pitchFamily="50" charset="-127"/>
              </a:rPr>
              <a:t>α, IĸBα, pNF-ĸB, and NF-ĸB antibodies. Equal protein loading was confirmed by β-actin in the protein extracts. The asterisk (*) indicates the main signal band. The black arrow indicates endogenous protein, and the blue arrow indicates the V5 tagged protein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139449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05</TotalTime>
  <Words>246</Words>
  <Application>Microsoft Office PowerPoint</Application>
  <PresentationFormat>사용자 지정</PresentationFormat>
  <Paragraphs>85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JooJaeyeol</cp:lastModifiedBy>
  <cp:revision>827</cp:revision>
  <cp:lastPrinted>2020-05-22T07:46:34Z</cp:lastPrinted>
  <dcterms:created xsi:type="dcterms:W3CDTF">2017-05-04T04:46:32Z</dcterms:created>
  <dcterms:modified xsi:type="dcterms:W3CDTF">2022-11-11T22:50:22Z</dcterms:modified>
</cp:coreProperties>
</file>